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752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04859-FDAD-447A-82BD-EC437D16C4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16CD7-F0D4-4505-A468-9E53C4F917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EF0A6-60B6-4113-B9E4-1705066F3B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5EC1A-D746-4157-AEE8-5470B7E8D1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7E44A-598E-4B16-B74E-C26F1961FC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8CD31-C0CD-4E6E-A0F3-3AF4DB33AC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87942-9AB5-47E0-BE54-82C6A2ABFF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B8E81-B1D2-4FCE-A3C9-428C48D7DD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869CA-6304-4402-A259-502430248F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A3F6D-783F-46E0-BA23-08090B36BD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0A676-6EBE-4022-B2AD-65C72EAF7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E4354-A972-46E2-AC8D-05BC068F7F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2049A5-97C7-49E5-BFB3-9E1986646921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2"/>
          <p:cNvSpPr/>
          <p:nvPr/>
        </p:nvSpPr>
        <p:spPr>
          <a:xfrm>
            <a:off x="549360" y="7524720"/>
            <a:ext cx="436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51"/>
          <p:cNvSpPr/>
          <p:nvPr/>
        </p:nvSpPr>
        <p:spPr>
          <a:xfrm>
            <a:off x="547560" y="7794720"/>
            <a:ext cx="60501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MP activities in cardiac biopsy sample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enzymatic activities of pro-MMP-2, MMP-2, pro-MMP-9 and MMP-9 were evaluated in tissue samples from 12 control patients with low cTnT levels (cTnT ≤0.32ng/ml; mean cTnT concentration 0.18±0.02 ng/ml) and 12 RIPC patients with high cTnT concentrations (“non-responder”; cTnT ≥0.32ng/ml; mean cTnT concentration 1.04±0.14 ng/ml 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ed to the control group the activities of both MMPs were by trend increased in the RIPC group with high cTnT level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rs denote SEM.  CPB, cardiopulmonary bypass; RIPC, remote ischemic precondition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06"/>
          <p:cNvSpPr/>
          <p:nvPr/>
        </p:nvSpPr>
        <p:spPr>
          <a:xfrm>
            <a:off x="1488600" y="100080"/>
            <a:ext cx="243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</a:rPr>
              <a:t>Serum concentration of cT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06"/>
          <p:cNvSpPr/>
          <p:nvPr/>
        </p:nvSpPr>
        <p:spPr>
          <a:xfrm>
            <a:off x="1810080" y="1687680"/>
            <a:ext cx="175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</a:rPr>
              <a:t>Activity of MMP-2/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306"/>
          <p:cNvSpPr/>
          <p:nvPr/>
        </p:nvSpPr>
        <p:spPr>
          <a:xfrm>
            <a:off x="871200" y="2097000"/>
            <a:ext cx="108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 u="sng">
                <a:solidFill>
                  <a:srgbClr val="000000"/>
                </a:solidFill>
                <a:uFillTx/>
                <a:latin typeface="Times New Roman"/>
              </a:rPr>
              <a:t>Before CP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06"/>
          <p:cNvSpPr/>
          <p:nvPr/>
        </p:nvSpPr>
        <p:spPr>
          <a:xfrm>
            <a:off x="3036240" y="2097000"/>
            <a:ext cx="94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 u="sng">
                <a:solidFill>
                  <a:srgbClr val="000000"/>
                </a:solidFill>
                <a:uFillTx/>
                <a:latin typeface="Times New Roman"/>
              </a:rPr>
              <a:t>AfterCP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5" descr=""/>
          <p:cNvPicPr/>
          <p:nvPr/>
        </p:nvPicPr>
        <p:blipFill>
          <a:blip r:embed="rId1"/>
          <a:stretch/>
        </p:blipFill>
        <p:spPr>
          <a:xfrm>
            <a:off x="503280" y="471600"/>
            <a:ext cx="1793880" cy="11491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6" descr=""/>
          <p:cNvPicPr/>
          <p:nvPr/>
        </p:nvPicPr>
        <p:blipFill>
          <a:blip r:embed="rId2"/>
          <a:stretch/>
        </p:blipFill>
        <p:spPr>
          <a:xfrm>
            <a:off x="522360" y="5005440"/>
            <a:ext cx="1731960" cy="11462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7" descr=""/>
          <p:cNvPicPr/>
          <p:nvPr/>
        </p:nvPicPr>
        <p:blipFill>
          <a:blip r:embed="rId3"/>
          <a:stretch/>
        </p:blipFill>
        <p:spPr>
          <a:xfrm>
            <a:off x="512640" y="6253200"/>
            <a:ext cx="1787760" cy="12254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0" descr=""/>
          <p:cNvPicPr/>
          <p:nvPr/>
        </p:nvPicPr>
        <p:blipFill>
          <a:blip r:embed="rId4"/>
          <a:stretch/>
        </p:blipFill>
        <p:spPr>
          <a:xfrm>
            <a:off x="2665440" y="5000760"/>
            <a:ext cx="1744560" cy="11476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1" descr=""/>
          <p:cNvPicPr/>
          <p:nvPr/>
        </p:nvPicPr>
        <p:blipFill>
          <a:blip r:embed="rId5"/>
          <a:stretch/>
        </p:blipFill>
        <p:spPr>
          <a:xfrm>
            <a:off x="2692440" y="6353280"/>
            <a:ext cx="1733400" cy="11476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8" descr=""/>
          <p:cNvPicPr/>
          <p:nvPr/>
        </p:nvPicPr>
        <p:blipFill>
          <a:blip r:embed="rId6"/>
          <a:stretch/>
        </p:blipFill>
        <p:spPr>
          <a:xfrm>
            <a:off x="504720" y="2441520"/>
            <a:ext cx="1731960" cy="11462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9" descr=""/>
          <p:cNvPicPr/>
          <p:nvPr/>
        </p:nvPicPr>
        <p:blipFill>
          <a:blip r:embed="rId7"/>
          <a:stretch/>
        </p:blipFill>
        <p:spPr>
          <a:xfrm>
            <a:off x="506520" y="3708360"/>
            <a:ext cx="1788840" cy="12002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2" descr=""/>
          <p:cNvPicPr/>
          <p:nvPr/>
        </p:nvPicPr>
        <p:blipFill>
          <a:blip r:embed="rId8"/>
          <a:stretch/>
        </p:blipFill>
        <p:spPr>
          <a:xfrm>
            <a:off x="2665440" y="2425680"/>
            <a:ext cx="1733400" cy="11476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3" descr=""/>
          <p:cNvPicPr/>
          <p:nvPr/>
        </p:nvPicPr>
        <p:blipFill>
          <a:blip r:embed="rId9"/>
          <a:stretch/>
        </p:blipFill>
        <p:spPr>
          <a:xfrm>
            <a:off x="2671920" y="3780000"/>
            <a:ext cx="1719000" cy="114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5T10:25:29Z</dcterms:created>
  <dc:creator>albrecht-ma</dc:creator>
  <dc:description/>
  <dc:language>en-US</dc:language>
  <cp:lastModifiedBy>Albrecht, Martin</cp:lastModifiedBy>
  <cp:lastPrinted>2014-02-06T10:57:01Z</cp:lastPrinted>
  <dcterms:modified xsi:type="dcterms:W3CDTF">2014-02-06T11:24:04Z</dcterms:modified>
  <cp:revision>41</cp:revision>
  <dc:subject/>
  <dc:title>Folie 1</dc:title>
</cp:coreProperties>
</file>